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24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A28FB-7660-4518-B9BA-750D96F562E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CE8D8-616A-40D6-ABA6-E0C2AEA5B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06797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A28FB-7660-4518-B9BA-750D96F562E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CE8D8-616A-40D6-ABA6-E0C2AEA5B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8776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A28FB-7660-4518-B9BA-750D96F562E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CE8D8-616A-40D6-ABA6-E0C2AEA5B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1633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A28FB-7660-4518-B9BA-750D96F562E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CE8D8-616A-40D6-ABA6-E0C2AEA5B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7959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A28FB-7660-4518-B9BA-750D96F562E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CE8D8-616A-40D6-ABA6-E0C2AEA5B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2883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A28FB-7660-4518-B9BA-750D96F562E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CE8D8-616A-40D6-ABA6-E0C2AEA5B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72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A28FB-7660-4518-B9BA-750D96F562E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CE8D8-616A-40D6-ABA6-E0C2AEA5B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546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A28FB-7660-4518-B9BA-750D96F562E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CE8D8-616A-40D6-ABA6-E0C2AEA5B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9456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A28FB-7660-4518-B9BA-750D96F562E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CE8D8-616A-40D6-ABA6-E0C2AEA5B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0926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A28FB-7660-4518-B9BA-750D96F562E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CE8D8-616A-40D6-ABA6-E0C2AEA5B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5488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A28FB-7660-4518-B9BA-750D96F562E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CE8D8-616A-40D6-ABA6-E0C2AEA5B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36099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3A28FB-7660-4518-B9BA-750D96F562E4}" type="datetimeFigureOut">
              <a:rPr lang="en-US" smtClean="0"/>
              <a:t>10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CE8D8-616A-40D6-ABA6-E0C2AEA5B6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2955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oup 114"/>
          <p:cNvGraphicFramePr>
            <a:graphicFrameLocks noGrp="1"/>
          </p:cNvGraphicFramePr>
          <p:nvPr/>
        </p:nvGraphicFramePr>
        <p:xfrm>
          <a:off x="319088" y="784225"/>
          <a:ext cx="8493125" cy="5322890"/>
        </p:xfrm>
        <a:graphic>
          <a:graphicData uri="http://schemas.openxmlformats.org/drawingml/2006/table">
            <a:tbl>
              <a:tblPr/>
              <a:tblGrid>
                <a:gridCol w="3376612"/>
                <a:gridCol w="868363"/>
                <a:gridCol w="912812"/>
                <a:gridCol w="842963"/>
                <a:gridCol w="911225"/>
                <a:gridCol w="693737"/>
                <a:gridCol w="887413"/>
              </a:tblGrid>
              <a:tr h="24923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it-IT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marL="68580" marR="68580" marT="34290" marB="34290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1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2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3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4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5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Tot.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7F7F7F"/>
                    </a:solidFill>
                  </a:tcPr>
                </a:tc>
              </a:tr>
              <a:tr h="538163">
                <a:tc>
                  <a:txBody>
                    <a:bodyPr/>
                    <a:lstStyle/>
                    <a:p>
                      <a:pPr marL="0" marR="0" lvl="0" indent="0" algn="l" defTabSz="4572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 1. C</a:t>
                      </a: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ardioembolic stroke risk not reduced after cardioversion from AF to sinus rhythm. </a:t>
                      </a:r>
                      <a:endParaRPr kumimoji="0" lang="it-IT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10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24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50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50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44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4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178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63525">
                <a:tc>
                  <a:txBody>
                    <a:bodyPr/>
                    <a:lstStyle/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it-IT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19%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81%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B05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it-IT" sz="11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569913">
                <a:tc>
                  <a:txBody>
                    <a:bodyPr/>
                    <a:lstStyle/>
                    <a:p>
                      <a:pPr marL="0" marR="0" lvl="0" indent="0" algn="l" defTabSz="4572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2. I</a:t>
                      </a: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nappropriate NOAC dose reduction may reduce the efficacy in preventing thromboembolic stroke compared to the full dose regimen.</a:t>
                      </a:r>
                      <a:r>
                        <a:rPr kumimoji="0" lang="it-IT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 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1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5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40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60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72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4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178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63525">
                <a:tc>
                  <a:txBody>
                    <a:bodyPr/>
                    <a:lstStyle/>
                    <a:p>
                      <a:pPr marL="0" marR="0" lvl="0" indent="0" algn="l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it-IT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3%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97%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B05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it-IT" sz="11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542925">
                <a:tc>
                  <a:txBody>
                    <a:bodyPr/>
                    <a:lstStyle/>
                    <a:p>
                      <a:pPr marL="0" marR="0" lvl="0" indent="0" algn="l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3.</a:t>
                      </a: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 Importance of self monitoring of heart rhythm by pulse taking in subjects older than 64 years of age. </a:t>
                      </a:r>
                      <a:endParaRPr kumimoji="0" lang="it-IT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5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29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63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34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47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4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178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40005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it-IT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19%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81%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B05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it-IT" sz="11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387350">
                <a:tc>
                  <a:txBody>
                    <a:bodyPr/>
                    <a:lstStyle/>
                    <a:p>
                      <a:pPr marL="0" marR="0" lvl="0" indent="0" algn="l" defTabSz="4572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 4. R</a:t>
                      </a:r>
                      <a:r>
                        <a:rPr kumimoji="0" 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isk of stroke associated with AF almost twice the risk associated with hypertension. </a:t>
                      </a:r>
                      <a:endParaRPr kumimoji="0" lang="it-IT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1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8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55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59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55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4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178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6352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it-IT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marL="68580" marR="68580" marT="34290" marB="3429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5%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95%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B05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it-IT" sz="11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61277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5.</a:t>
                      </a:r>
                      <a:r>
                        <a:rPr kumimoji="0" lang="en-GB" sz="1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 </a:t>
                      </a:r>
                      <a:r>
                        <a:rPr kumimoji="0" lang="en-GB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CHA</a:t>
                      </a:r>
                      <a:r>
                        <a:rPr kumimoji="0" lang="en-GB" sz="1100" b="0" i="0" u="none" strike="noStrike" cap="none" normalizeH="0" baseline="-25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2</a:t>
                      </a:r>
                      <a:r>
                        <a:rPr kumimoji="0" lang="en-GB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DS</a:t>
                      </a:r>
                      <a:r>
                        <a:rPr kumimoji="0" lang="en-GB" sz="1100" b="0" i="0" u="none" strike="noStrike" cap="none" normalizeH="0" baseline="-25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2</a:t>
                      </a:r>
                      <a:r>
                        <a:rPr kumimoji="0" lang="en-GB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-VASc score exerting higher influence on stroke risk compared to AF duration.</a:t>
                      </a:r>
                      <a:endParaRPr kumimoji="0" lang="it-IT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marL="68580" marR="68580" marT="34290" marB="3429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4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11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42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71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50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4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178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30321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it-IT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marL="68580" marR="68580" marT="34290" marB="3429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8%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92%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B05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it-IT" sz="11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63817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6. S</a:t>
                      </a:r>
                      <a:r>
                        <a:rPr kumimoji="0" lang="en-GB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troke prevention in AF with a NOAC more effective, without higher bleeding risk, and equally simple compared to aspirin treatment. </a:t>
                      </a:r>
                      <a:endParaRPr kumimoji="0" lang="it-IT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marL="68580" marR="68580" marT="34290" marB="3429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7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9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37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53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72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4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178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9051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it-IT" sz="11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marL="68580" marR="68580" marT="34290" marB="3429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9%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5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91%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B05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it-IT" sz="11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  <p:sp>
        <p:nvSpPr>
          <p:cNvPr id="5" name="Rettangolo 3"/>
          <p:cNvSpPr>
            <a:spLocks noChangeArrowheads="1"/>
          </p:cNvSpPr>
          <p:nvPr/>
        </p:nvSpPr>
        <p:spPr bwMode="auto">
          <a:xfrm>
            <a:off x="319088" y="61913"/>
            <a:ext cx="8824912" cy="4270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defTabSz="685800"/>
            <a:r>
              <a:rPr lang="it-IT" sz="2200" b="1">
                <a:latin typeface="Calibri" pitchFamily="34" charset="0"/>
              </a:rPr>
              <a:t>Statement 8 </a:t>
            </a:r>
            <a:r>
              <a:rPr lang="en-US" sz="2200" b="1">
                <a:latin typeface="Calibri" pitchFamily="34" charset="0"/>
              </a:rPr>
              <a:t>–</a:t>
            </a:r>
            <a:r>
              <a:rPr lang="it-IT" sz="2200" b="1">
                <a:latin typeface="Calibri" pitchFamily="34" charset="0"/>
              </a:rPr>
              <a:t> </a:t>
            </a:r>
            <a:r>
              <a:rPr lang="en-US" sz="2200" b="1">
                <a:latin typeface="Calibri" pitchFamily="34" charset="0"/>
              </a:rPr>
              <a:t>An informative AF campaign should include knowledge of:</a:t>
            </a:r>
            <a:r>
              <a:rPr lang="it-IT" sz="2200" b="1">
                <a:latin typeface="Calibri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40734748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8</Words>
  <Application>Microsoft Office PowerPoint</Application>
  <PresentationFormat>On-screen Show (4:3)</PresentationFormat>
  <Paragraphs>6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rmendra</dc:creator>
  <cp:lastModifiedBy>Dharmendra</cp:lastModifiedBy>
  <cp:revision>1</cp:revision>
  <dcterms:created xsi:type="dcterms:W3CDTF">2017-10-06T00:06:44Z</dcterms:created>
  <dcterms:modified xsi:type="dcterms:W3CDTF">2017-10-06T00:07:04Z</dcterms:modified>
</cp:coreProperties>
</file>